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B8C71-9E03-42D0-8BA1-F3183172E0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D9844-6090-4A7B-9496-CE077DFC0E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6AEFA-5377-40D3-9509-D6A78646AA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AAA11-7B40-4685-AAB7-975AE8C62A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F9109F-04EF-4863-A178-DB53F26731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DBFAF-2991-45B6-9270-B85FAB3B99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C8A61-43CB-4A45-9373-B82B094E5A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CBA8E-63DE-44AD-A2A5-EC0D2224AE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09518-B4CD-40B7-9D5D-F1AD60E537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C9AAD-EA3E-4675-8B3A-F771851C81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B75A79-7447-4494-A2B8-571AFBE722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BEBBD-9009-429D-870D-6DD4B39EEA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5CF03C-79D2-440B-AEAB-568745FBF70B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76320" y="809640"/>
            <a:ext cx="9144000" cy="4638600"/>
          </a:xfrm>
          <a:prstGeom prst="rect">
            <a:avLst/>
          </a:prstGeom>
          <a:ln w="0">
            <a:noFill/>
          </a:ln>
        </p:spPr>
      </p:pic>
      <p:grpSp>
        <p:nvGrpSpPr>
          <p:cNvPr id="42" name="Group 52"/>
          <p:cNvGrpSpPr/>
          <p:nvPr/>
        </p:nvGrpSpPr>
        <p:grpSpPr>
          <a:xfrm>
            <a:off x="2216880" y="3006720"/>
            <a:ext cx="1051200" cy="581400"/>
            <a:chOff x="2216880" y="3006720"/>
            <a:chExt cx="1051200" cy="581400"/>
          </a:xfrm>
        </p:grpSpPr>
        <p:sp>
          <p:nvSpPr>
            <p:cNvPr id="43" name="Rectangle 85"/>
            <p:cNvSpPr/>
            <p:nvPr/>
          </p:nvSpPr>
          <p:spPr>
            <a:xfrm>
              <a:off x="2229480" y="3006720"/>
              <a:ext cx="1038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 u="sng">
                  <a:solidFill>
                    <a:srgbClr val="00b050"/>
                  </a:solidFill>
                  <a:uFillTx/>
                  <a:latin typeface="Arial Narrow"/>
                  <a:ea typeface="Arial"/>
                </a:rPr>
                <a:t>VANC/90/UBC/55/minor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95"/>
            <p:cNvSpPr/>
            <p:nvPr/>
          </p:nvSpPr>
          <p:spPr>
            <a:xfrm>
              <a:off x="2216880" y="3450600"/>
              <a:ext cx="750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b050"/>
                  </a:solidFill>
                  <a:latin typeface="Arial Narrow"/>
                  <a:ea typeface="Arial"/>
                </a:rPr>
                <a:t>VANC/90/UBC/5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106"/>
            <p:cNvSpPr/>
            <p:nvPr/>
          </p:nvSpPr>
          <p:spPr>
            <a:xfrm>
              <a:off x="2216880" y="3299760"/>
              <a:ext cx="750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c00000"/>
                  </a:solidFill>
                  <a:latin typeface="Arial Narrow"/>
                  <a:ea typeface="Arial"/>
                </a:rPr>
                <a:t>VANC/87/UBC/2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tangle 132"/>
            <p:cNvSpPr/>
            <p:nvPr/>
          </p:nvSpPr>
          <p:spPr>
            <a:xfrm>
              <a:off x="2216880" y="3160800"/>
              <a:ext cx="750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c00000"/>
                  </a:solidFill>
                  <a:latin typeface="Arial Narrow"/>
                  <a:ea typeface="Arial"/>
                </a:rPr>
                <a:t>VANC/90/UBC/4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7" name="Rectangle 123"/>
          <p:cNvSpPr/>
          <p:nvPr/>
        </p:nvSpPr>
        <p:spPr>
          <a:xfrm>
            <a:off x="1149840" y="3363840"/>
            <a:ext cx="776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3/UBC/39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88"/>
          <p:cNvSpPr/>
          <p:nvPr/>
        </p:nvSpPr>
        <p:spPr>
          <a:xfrm>
            <a:off x="948960" y="3814920"/>
            <a:ext cx="802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2/UBC/10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98"/>
          <p:cNvSpPr/>
          <p:nvPr/>
        </p:nvSpPr>
        <p:spPr>
          <a:xfrm>
            <a:off x="948240" y="4348080"/>
            <a:ext cx="69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6/UBC/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20"/>
          <p:cNvSpPr/>
          <p:nvPr/>
        </p:nvSpPr>
        <p:spPr>
          <a:xfrm>
            <a:off x="1692000" y="4937040"/>
            <a:ext cx="69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5/UBC/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124"/>
          <p:cNvSpPr/>
          <p:nvPr/>
        </p:nvSpPr>
        <p:spPr>
          <a:xfrm>
            <a:off x="1693080" y="5075280"/>
            <a:ext cx="750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7/UBC/2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90"/>
          <p:cNvSpPr/>
          <p:nvPr/>
        </p:nvSpPr>
        <p:spPr>
          <a:xfrm>
            <a:off x="7240680" y="2152800"/>
            <a:ext cx="750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0/UBC/6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01"/>
          <p:cNvSpPr/>
          <p:nvPr/>
        </p:nvSpPr>
        <p:spPr>
          <a:xfrm>
            <a:off x="6174360" y="911160"/>
            <a:ext cx="648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ATCC50163/8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17"/>
          <p:cNvSpPr/>
          <p:nvPr/>
        </p:nvSpPr>
        <p:spPr>
          <a:xfrm>
            <a:off x="2720880" y="4565520"/>
            <a:ext cx="69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85/UBC/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94"/>
          <p:cNvSpPr/>
          <p:nvPr/>
        </p:nvSpPr>
        <p:spPr>
          <a:xfrm>
            <a:off x="5349240" y="4440240"/>
            <a:ext cx="1976040" cy="137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8/UBC/35, VANC/89/UBC/36,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9/UBC/37, VANC/90/UBC/43,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90/UBC/52, </a:t>
            </a: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0/UBC/71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0/UBC/64, VANC/93/UBC/70,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1/UBC/73, HAMILTON7/75,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HAMILTON84/76, WHANGAREI8/79,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2/UBC/101, VANC/92/UBC/104,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CB2/108, BTW/109, </a:t>
            </a:r>
            <a:r>
              <a:rPr b="1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3/UBC/106/major,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4/UBC/121,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113"/>
          <p:cNvSpPr/>
          <p:nvPr/>
        </p:nvSpPr>
        <p:spPr>
          <a:xfrm>
            <a:off x="3521160" y="4457880"/>
            <a:ext cx="1623960" cy="123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ATCC50803, ATCC30888/13,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ATCC50170/93, </a:t>
            </a: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5/UBC/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5/UBC/5, </a:t>
            </a: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MONASTASHE/6,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BE/2/IPO583/1/14, BE/1/IP/0482/1/15,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D3/18, B5/19, SI/16,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87/UBC/27/major,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87/UBC/28, VANC/87/UBC/29,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9/UBC/33, VANC/88/UBC/34,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,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Arc 51"/>
          <p:cNvSpPr/>
          <p:nvPr/>
        </p:nvSpPr>
        <p:spPr>
          <a:xfrm rot="17146800">
            <a:off x="268920" y="3074040"/>
            <a:ext cx="2751120" cy="1724040"/>
          </a:xfrm>
          <a:custGeom>
            <a:avLst/>
            <a:gdLst/>
            <a:ahLst/>
            <a:rect l="l" t="t" r="r" b="b"/>
            <a:pathLst>
              <a:path stroke="0" w="2751317" h="1724518">
                <a:moveTo>
                  <a:pt x="78310" y="1149031"/>
                </a:moveTo>
                <a:cubicBezTo>
                  <a:pt x="-163692" y="718908"/>
                  <a:pt x="170555" y="245052"/>
                  <a:pt x="840995" y="67790"/>
                </a:cubicBezTo>
                <a:cubicBezTo>
                  <a:pt x="1186697" y="-23613"/>
                  <a:pt x="1576961" y="-22544"/>
                  <a:pt x="1921375" y="70748"/>
                </a:cubicBezTo>
                <a:cubicBezTo>
                  <a:pt x="2593198" y="252726"/>
                  <a:pt x="2920084" y="732551"/>
                  <a:pt x="2665189" y="1162566"/>
                </a:cubicBezTo>
                <a:lnTo>
                  <a:pt x="1375659" y="862259"/>
                </a:lnTo>
                <a:lnTo>
                  <a:pt x="78310" y="1149031"/>
                </a:lnTo>
                <a:close/>
              </a:path>
              <a:path fill="none" w="2751317" h="1724518">
                <a:moveTo>
                  <a:pt x="78310" y="1149031"/>
                </a:moveTo>
                <a:cubicBezTo>
                  <a:pt x="-163692" y="718908"/>
                  <a:pt x="170555" y="245052"/>
                  <a:pt x="840995" y="67790"/>
                </a:cubicBezTo>
                <a:cubicBezTo>
                  <a:pt x="1186697" y="-23613"/>
                  <a:pt x="1576961" y="-22544"/>
                  <a:pt x="1921375" y="70748"/>
                </a:cubicBezTo>
                <a:cubicBezTo>
                  <a:pt x="2593198" y="252726"/>
                  <a:pt x="2920084" y="732551"/>
                  <a:pt x="2665189" y="1162566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53"/>
          <p:cNvSpPr/>
          <p:nvPr/>
        </p:nvSpPr>
        <p:spPr>
          <a:xfrm>
            <a:off x="261720" y="2747880"/>
            <a:ext cx="39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 Narrow"/>
              </a:rPr>
              <a:t>A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54"/>
          <p:cNvSpPr/>
          <p:nvPr/>
        </p:nvSpPr>
        <p:spPr>
          <a:xfrm>
            <a:off x="8655480" y="4287960"/>
            <a:ext cx="39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 Narrow"/>
              </a:rPr>
              <a:t>A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Arc 57"/>
          <p:cNvSpPr/>
          <p:nvPr/>
        </p:nvSpPr>
        <p:spPr>
          <a:xfrm rot="1003200">
            <a:off x="3414600" y="591840"/>
            <a:ext cx="5173920" cy="5951520"/>
          </a:xfrm>
          <a:custGeom>
            <a:avLst/>
            <a:gdLst/>
            <a:ahLst/>
            <a:rect l="l" t="t" r="r" b="b"/>
            <a:pathLst>
              <a:path stroke="0" w="5173707" h="5952251">
                <a:moveTo>
                  <a:pt x="2224874" y="29281"/>
                </a:moveTo>
                <a:cubicBezTo>
                  <a:pt x="3359279" y="-155158"/>
                  <a:pt x="4464007" y="540831"/>
                  <a:pt x="4939938" y="1739798"/>
                </a:cubicBezTo>
                <a:cubicBezTo>
                  <a:pt x="5338451" y="2743731"/>
                  <a:pt x="5221337" y="3918949"/>
                  <a:pt x="4635672" y="4793068"/>
                </a:cubicBezTo>
                <a:cubicBezTo>
                  <a:pt x="3910218" y="5875825"/>
                  <a:pt x="2636895" y="6250721"/>
                  <a:pt x="1548534" y="5701991"/>
                </a:cubicBezTo>
                <a:lnTo>
                  <a:pt x="2586854" y="2976126"/>
                </a:lnTo>
                <a:lnTo>
                  <a:pt x="2224874" y="29281"/>
                </a:lnTo>
                <a:close/>
              </a:path>
              <a:path fill="none" w="5173707" h="5952251">
                <a:moveTo>
                  <a:pt x="2224874" y="29281"/>
                </a:moveTo>
                <a:cubicBezTo>
                  <a:pt x="3359279" y="-155158"/>
                  <a:pt x="4464007" y="540831"/>
                  <a:pt x="4939938" y="1739798"/>
                </a:cubicBezTo>
                <a:cubicBezTo>
                  <a:pt x="5338451" y="2743731"/>
                  <a:pt x="5221337" y="3918949"/>
                  <a:pt x="4635672" y="4793068"/>
                </a:cubicBezTo>
                <a:cubicBezTo>
                  <a:pt x="3910218" y="5875825"/>
                  <a:pt x="2636895" y="6250721"/>
                  <a:pt x="1548534" y="5701991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"/>
          <p:cNvSpPr/>
          <p:nvPr/>
        </p:nvSpPr>
        <p:spPr>
          <a:xfrm>
            <a:off x="7960680" y="209520"/>
            <a:ext cx="982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. S2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4" descr=""/>
          <p:cNvPicPr/>
          <p:nvPr/>
        </p:nvPicPr>
        <p:blipFill>
          <a:blip r:embed="rId1"/>
          <a:stretch/>
        </p:blipFill>
        <p:spPr>
          <a:xfrm>
            <a:off x="0" y="797040"/>
            <a:ext cx="9144000" cy="5263920"/>
          </a:xfrm>
          <a:prstGeom prst="rect">
            <a:avLst/>
          </a:prstGeom>
          <a:ln w="0">
            <a:noFill/>
          </a:ln>
        </p:spPr>
      </p:pic>
      <p:sp>
        <p:nvSpPr>
          <p:cNvPr id="63" name="Rectangle 142"/>
          <p:cNvSpPr/>
          <p:nvPr/>
        </p:nvSpPr>
        <p:spPr>
          <a:xfrm>
            <a:off x="690120" y="5257800"/>
            <a:ext cx="689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7/UBC/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153"/>
          <p:cNvSpPr/>
          <p:nvPr/>
        </p:nvSpPr>
        <p:spPr>
          <a:xfrm>
            <a:off x="7673400" y="2833560"/>
            <a:ext cx="715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85/UBC/9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128"/>
          <p:cNvSpPr/>
          <p:nvPr/>
        </p:nvSpPr>
        <p:spPr>
          <a:xfrm>
            <a:off x="7234920" y="348156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1/UBC/7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152"/>
          <p:cNvSpPr/>
          <p:nvPr/>
        </p:nvSpPr>
        <p:spPr>
          <a:xfrm>
            <a:off x="7234920" y="334008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1/UBC/6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113"/>
          <p:cNvSpPr/>
          <p:nvPr/>
        </p:nvSpPr>
        <p:spPr>
          <a:xfrm>
            <a:off x="6863760" y="5140440"/>
            <a:ext cx="793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2/UBC/10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119"/>
          <p:cNvSpPr/>
          <p:nvPr/>
        </p:nvSpPr>
        <p:spPr>
          <a:xfrm>
            <a:off x="6863760" y="5272200"/>
            <a:ext cx="793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2/UBC/10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ectangle 124"/>
          <p:cNvSpPr/>
          <p:nvPr/>
        </p:nvSpPr>
        <p:spPr>
          <a:xfrm>
            <a:off x="6863400" y="422928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 Narrow"/>
                <a:ea typeface="Arial"/>
              </a:rPr>
              <a:t>VANC/90/UBC/4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125"/>
          <p:cNvSpPr/>
          <p:nvPr/>
        </p:nvSpPr>
        <p:spPr>
          <a:xfrm>
            <a:off x="6863400" y="448452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 Narrow"/>
                <a:ea typeface="Arial"/>
              </a:rPr>
              <a:t>VANC/90/UBC/4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126"/>
          <p:cNvSpPr/>
          <p:nvPr/>
        </p:nvSpPr>
        <p:spPr>
          <a:xfrm>
            <a:off x="6863400" y="435600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 Narrow"/>
                <a:ea typeface="Arial"/>
              </a:rPr>
              <a:t>VANC/90/UBC/4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129"/>
          <p:cNvSpPr/>
          <p:nvPr/>
        </p:nvSpPr>
        <p:spPr>
          <a:xfrm>
            <a:off x="6873840" y="474516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0/UBC/4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135"/>
          <p:cNvSpPr/>
          <p:nvPr/>
        </p:nvSpPr>
        <p:spPr>
          <a:xfrm>
            <a:off x="5645520" y="4319640"/>
            <a:ext cx="1000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90/UBC/55/majo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136"/>
          <p:cNvSpPr/>
          <p:nvPr/>
        </p:nvSpPr>
        <p:spPr>
          <a:xfrm>
            <a:off x="6863400" y="461628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 Narrow"/>
                <a:ea typeface="Arial"/>
              </a:rPr>
              <a:t>VANC/90/UBC/4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 138"/>
          <p:cNvSpPr/>
          <p:nvPr/>
        </p:nvSpPr>
        <p:spPr>
          <a:xfrm>
            <a:off x="5949000" y="461340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90/UBC/5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141"/>
          <p:cNvSpPr/>
          <p:nvPr/>
        </p:nvSpPr>
        <p:spPr>
          <a:xfrm>
            <a:off x="5949000" y="446724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90/UBC/5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145"/>
          <p:cNvSpPr/>
          <p:nvPr/>
        </p:nvSpPr>
        <p:spPr>
          <a:xfrm>
            <a:off x="6863400" y="501336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 Narrow"/>
                <a:ea typeface="Arial"/>
              </a:rPr>
              <a:t>VANC/90/UBC/6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154"/>
          <p:cNvSpPr/>
          <p:nvPr/>
        </p:nvSpPr>
        <p:spPr>
          <a:xfrm>
            <a:off x="6863400" y="409896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0/UBC/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Rectangle 155"/>
          <p:cNvSpPr/>
          <p:nvPr/>
        </p:nvSpPr>
        <p:spPr>
          <a:xfrm>
            <a:off x="6861960" y="4878360"/>
            <a:ext cx="819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0/UBC/50/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ectangle 112"/>
          <p:cNvSpPr/>
          <p:nvPr/>
        </p:nvSpPr>
        <p:spPr>
          <a:xfrm>
            <a:off x="3468600" y="4970520"/>
            <a:ext cx="1800" cy="13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114"/>
          <p:cNvSpPr/>
          <p:nvPr/>
        </p:nvSpPr>
        <p:spPr>
          <a:xfrm>
            <a:off x="3701880" y="561024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7/UBC/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ectangle 115"/>
          <p:cNvSpPr/>
          <p:nvPr/>
        </p:nvSpPr>
        <p:spPr>
          <a:xfrm>
            <a:off x="3462480" y="4121280"/>
            <a:ext cx="360" cy="13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angle 120"/>
          <p:cNvSpPr/>
          <p:nvPr/>
        </p:nvSpPr>
        <p:spPr>
          <a:xfrm>
            <a:off x="3468600" y="5224320"/>
            <a:ext cx="36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ectangle 122"/>
          <p:cNvSpPr/>
          <p:nvPr/>
        </p:nvSpPr>
        <p:spPr>
          <a:xfrm>
            <a:off x="3468600" y="5100480"/>
            <a:ext cx="180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ectangle 127"/>
          <p:cNvSpPr/>
          <p:nvPr/>
        </p:nvSpPr>
        <p:spPr>
          <a:xfrm>
            <a:off x="3462480" y="4367160"/>
            <a:ext cx="144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133"/>
          <p:cNvSpPr/>
          <p:nvPr/>
        </p:nvSpPr>
        <p:spPr>
          <a:xfrm>
            <a:off x="3462480" y="4727520"/>
            <a:ext cx="144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139"/>
          <p:cNvSpPr/>
          <p:nvPr/>
        </p:nvSpPr>
        <p:spPr>
          <a:xfrm>
            <a:off x="3462480" y="4608360"/>
            <a:ext cx="144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143"/>
          <p:cNvSpPr/>
          <p:nvPr/>
        </p:nvSpPr>
        <p:spPr>
          <a:xfrm>
            <a:off x="3462480" y="4487760"/>
            <a:ext cx="144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ectangle 148"/>
          <p:cNvSpPr/>
          <p:nvPr/>
        </p:nvSpPr>
        <p:spPr>
          <a:xfrm>
            <a:off x="3462480" y="4848120"/>
            <a:ext cx="144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150"/>
          <p:cNvSpPr/>
          <p:nvPr/>
        </p:nvSpPr>
        <p:spPr>
          <a:xfrm>
            <a:off x="3698280" y="4903920"/>
            <a:ext cx="1896480" cy="68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0/UBC/58, VANC/91/UBC/7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1/UBC/85, VANC/92/UBC/9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2/UBC/99, VANC/93/UBC/10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u="sng">
                <a:solidFill>
                  <a:srgbClr val="0070c0"/>
                </a:solidFill>
                <a:uFillTx/>
                <a:latin typeface="Arial Narrow"/>
                <a:ea typeface="Arial"/>
              </a:rPr>
              <a:t>VANC/93/UBC/106/minor, </a:t>
            </a: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4/UBC/12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4/UBC/124, VANC/94/UBC/1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tangle 110"/>
          <p:cNvSpPr/>
          <p:nvPr/>
        </p:nvSpPr>
        <p:spPr>
          <a:xfrm>
            <a:off x="4714920" y="1031760"/>
            <a:ext cx="1052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u="sng">
                <a:solidFill>
                  <a:srgbClr val="c00000"/>
                </a:solidFill>
                <a:uFillTx/>
                <a:latin typeface="Arial Narrow"/>
                <a:ea typeface="Arial"/>
              </a:rPr>
              <a:t>VANC/96/UBC/126/mino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144"/>
          <p:cNvSpPr/>
          <p:nvPr/>
        </p:nvSpPr>
        <p:spPr>
          <a:xfrm>
            <a:off x="4712760" y="1187280"/>
            <a:ext cx="793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96/UBC/12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ectangle 149"/>
          <p:cNvSpPr/>
          <p:nvPr/>
        </p:nvSpPr>
        <p:spPr>
          <a:xfrm>
            <a:off x="4712760" y="762120"/>
            <a:ext cx="793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6/UBC/12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156"/>
          <p:cNvSpPr/>
          <p:nvPr/>
        </p:nvSpPr>
        <p:spPr>
          <a:xfrm>
            <a:off x="4712760" y="903240"/>
            <a:ext cx="793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6/UBC/12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Rectangle 134"/>
          <p:cNvSpPr/>
          <p:nvPr/>
        </p:nvSpPr>
        <p:spPr>
          <a:xfrm>
            <a:off x="5753880" y="1371600"/>
            <a:ext cx="6379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u="sng">
                <a:solidFill>
                  <a:srgbClr val="00b050"/>
                </a:solidFill>
                <a:uFillTx/>
                <a:latin typeface="Arial Narrow"/>
                <a:ea typeface="Arial"/>
              </a:rPr>
              <a:t>VANC/87/UBC/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u="sng">
                <a:solidFill>
                  <a:srgbClr val="00b050"/>
                </a:solidFill>
                <a:uFillTx/>
                <a:latin typeface="Arial Narrow"/>
                <a:ea typeface="Arial"/>
              </a:rPr>
              <a:t>27/mino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Rectangle 118"/>
          <p:cNvSpPr/>
          <p:nvPr/>
        </p:nvSpPr>
        <p:spPr>
          <a:xfrm>
            <a:off x="843840" y="373392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90/UBC/5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Rectangle 147"/>
          <p:cNvSpPr/>
          <p:nvPr/>
        </p:nvSpPr>
        <p:spPr>
          <a:xfrm>
            <a:off x="4418640" y="160020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0/UBC/6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116"/>
          <p:cNvSpPr/>
          <p:nvPr/>
        </p:nvSpPr>
        <p:spPr>
          <a:xfrm>
            <a:off x="3675600" y="176364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0/UBC/6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ectangle 140"/>
          <p:cNvSpPr/>
          <p:nvPr/>
        </p:nvSpPr>
        <p:spPr>
          <a:xfrm>
            <a:off x="3583800" y="193680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1/UBC/6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121"/>
          <p:cNvSpPr/>
          <p:nvPr/>
        </p:nvSpPr>
        <p:spPr>
          <a:xfrm>
            <a:off x="6819840" y="205740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90/UBC/4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123"/>
          <p:cNvSpPr/>
          <p:nvPr/>
        </p:nvSpPr>
        <p:spPr>
          <a:xfrm>
            <a:off x="5815080" y="172872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c00000"/>
                </a:solidFill>
                <a:latin typeface="Arial Narrow"/>
                <a:ea typeface="Arial"/>
              </a:rPr>
              <a:t>VANC/89/UBC/4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146"/>
          <p:cNvSpPr/>
          <p:nvPr/>
        </p:nvSpPr>
        <p:spPr>
          <a:xfrm>
            <a:off x="6766560" y="172080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0/UBC/5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117"/>
          <p:cNvSpPr/>
          <p:nvPr/>
        </p:nvSpPr>
        <p:spPr>
          <a:xfrm>
            <a:off x="2834280" y="238284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87/UBC/2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130"/>
          <p:cNvSpPr/>
          <p:nvPr/>
        </p:nvSpPr>
        <p:spPr>
          <a:xfrm>
            <a:off x="2832840" y="264492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b050"/>
                </a:solidFill>
                <a:latin typeface="Arial Narrow"/>
                <a:ea typeface="Arial"/>
              </a:rPr>
              <a:t>VANC/89/UBC/5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137"/>
          <p:cNvSpPr/>
          <p:nvPr/>
        </p:nvSpPr>
        <p:spPr>
          <a:xfrm>
            <a:off x="2832840" y="251316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2/UBC/8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Rectangle 111"/>
          <p:cNvSpPr/>
          <p:nvPr/>
        </p:nvSpPr>
        <p:spPr>
          <a:xfrm>
            <a:off x="7395480" y="2593800"/>
            <a:ext cx="819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1/UBC/68/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Rectangle 131"/>
          <p:cNvSpPr/>
          <p:nvPr/>
        </p:nvSpPr>
        <p:spPr>
          <a:xfrm>
            <a:off x="7383240" y="2320920"/>
            <a:ext cx="741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1/UBC/6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Rectangle 132"/>
          <p:cNvSpPr/>
          <p:nvPr/>
        </p:nvSpPr>
        <p:spPr>
          <a:xfrm>
            <a:off x="7384320" y="2440080"/>
            <a:ext cx="819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70c0"/>
                </a:solidFill>
                <a:latin typeface="Arial Narrow"/>
                <a:ea typeface="Arial"/>
              </a:rPr>
              <a:t>VANC/91/UBC/68/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9" name="Straight Arrow Connector 51"/>
          <p:cNvCxnSpPr/>
          <p:nvPr/>
        </p:nvCxnSpPr>
        <p:spPr>
          <a:xfrm flipH="1" flipV="1">
            <a:off x="5239440" y="1370880"/>
            <a:ext cx="258120" cy="562680"/>
          </a:xfrm>
          <a:prstGeom prst="straightConnector1">
            <a:avLst/>
          </a:prstGeom>
          <a:ln w="9360">
            <a:solidFill>
              <a:srgbClr val="404040"/>
            </a:solidFill>
            <a:miter/>
            <a:tailEnd len="med" type="arrow" w="med"/>
          </a:ln>
        </p:spPr>
      </p:cxnSp>
      <p:sp>
        <p:nvSpPr>
          <p:cNvPr id="110" name="TextBox 52"/>
          <p:cNvSpPr/>
          <p:nvPr/>
        </p:nvSpPr>
        <p:spPr>
          <a:xfrm>
            <a:off x="7959960" y="209520"/>
            <a:ext cx="994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. S2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7-16T05:11:04Z</dcterms:created>
  <dc:creator>Clement</dc:creator>
  <dc:description/>
  <dc:language>en-US</dc:language>
  <cp:lastModifiedBy>Clement</cp:lastModifiedBy>
  <dcterms:modified xsi:type="dcterms:W3CDTF">2018-02-17T15:42:35Z</dcterms:modified>
  <cp:revision>34</cp:revision>
  <dc:subject/>
  <dc:title>PowerPoint Presentation</dc:title>
</cp:coreProperties>
</file>